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90" autoAdjust="0"/>
    <p:restoredTop sz="94660"/>
  </p:normalViewPr>
  <p:slideViewPr>
    <p:cSldViewPr snapToGrid="0">
      <p:cViewPr>
        <p:scale>
          <a:sx n="75" d="100"/>
          <a:sy n="75" d="100"/>
        </p:scale>
        <p:origin x="2352" y="-2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8282A-F213-4125-9B0A-9244F84DCE1B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B422-E544-427C-A0B1-8084637E1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461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8282A-F213-4125-9B0A-9244F84DCE1B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B422-E544-427C-A0B1-8084637E1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652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8282A-F213-4125-9B0A-9244F84DCE1B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B422-E544-427C-A0B1-8084637E1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394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8282A-F213-4125-9B0A-9244F84DCE1B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B422-E544-427C-A0B1-8084637E1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407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8282A-F213-4125-9B0A-9244F84DCE1B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B422-E544-427C-A0B1-8084637E1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7440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8282A-F213-4125-9B0A-9244F84DCE1B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B422-E544-427C-A0B1-8084637E1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429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8282A-F213-4125-9B0A-9244F84DCE1B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B422-E544-427C-A0B1-8084637E1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053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8282A-F213-4125-9B0A-9244F84DCE1B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B422-E544-427C-A0B1-8084637E1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30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8282A-F213-4125-9B0A-9244F84DCE1B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B422-E544-427C-A0B1-8084637E1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098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8282A-F213-4125-9B0A-9244F84DCE1B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B422-E544-427C-A0B1-8084637E1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1256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8282A-F213-4125-9B0A-9244F84DCE1B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B422-E544-427C-A0B1-8084637E1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066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28282A-F213-4125-9B0A-9244F84DCE1B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EDB422-E544-427C-A0B1-8084637E1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135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99955" y="694961"/>
            <a:ext cx="6680455" cy="1627874"/>
            <a:chOff x="88938" y="7261014"/>
            <a:chExt cx="6680455" cy="1627874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09" r="52066" b="68660"/>
            <a:stretch/>
          </p:blipFill>
          <p:spPr>
            <a:xfrm>
              <a:off x="4607439" y="7261014"/>
              <a:ext cx="2161954" cy="161040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20" r="53373" b="68322"/>
            <a:stretch/>
          </p:blipFill>
          <p:spPr>
            <a:xfrm>
              <a:off x="2340686" y="7261119"/>
              <a:ext cx="2160755" cy="1627769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3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203" r="54898" b="68523"/>
            <a:stretch/>
          </p:blipFill>
          <p:spPr>
            <a:xfrm>
              <a:off x="88938" y="7262610"/>
              <a:ext cx="2119087" cy="1617488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211322" y="8466833"/>
              <a:ext cx="147471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au </a:t>
              </a:r>
            </a:p>
            <a:p>
              <a:r>
                <a:rPr lang="en-US" sz="10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hosphoThr231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326509" y="8600183"/>
              <a:ext cx="7539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842990" y="8619233"/>
              <a:ext cx="8046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d</a:t>
              </a: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99955" y="2655065"/>
            <a:ext cx="668045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etection of secreted and phosphorylated tau in HGSOC ascites and cell lines. Tau phosphoThr231 primary antibodies (1:100 dilution), and anti-mouse AlexaFluor488 secondary antibodies were used to detect subcellular localization of the tau species (green fluorescence) in OVCAR-4 with immunofluorescence staining. Nuclear DNA was detected by staining with DAPI. Images were acquired using Zeiss fluorescence microscope. Left panels – tau (green), center panels – DAPI (blue). Right panels: images of tau and DAPI were superimposed using Zeiss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xiover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oftware.</a:t>
            </a:r>
          </a:p>
        </p:txBody>
      </p:sp>
    </p:spTree>
    <p:extLst>
      <p:ext uri="{BB962C8B-B14F-4D97-AF65-F5344CB8AC3E}">
        <p14:creationId xmlns:p14="http://schemas.microsoft.com/office/powerpoint/2010/main" val="20688794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22</TotalTime>
  <Words>100</Words>
  <Application>Microsoft Office PowerPoint</Application>
  <PresentationFormat>Letter Paper (8.5x11 in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IC College of Pharmac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MDPI</cp:lastModifiedBy>
  <cp:revision>4</cp:revision>
  <dcterms:created xsi:type="dcterms:W3CDTF">2022-08-18T19:08:09Z</dcterms:created>
  <dcterms:modified xsi:type="dcterms:W3CDTF">2022-09-20T02:25:29Z</dcterms:modified>
</cp:coreProperties>
</file>